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52" d="100"/>
          <a:sy n="52" d="100"/>
        </p:scale>
        <p:origin x="-2904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CH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A757C-A685-414B-9047-28E9F3FC19BD}" type="datetimeFigureOut">
              <a:rPr lang="fr-FR" smtClean="0"/>
              <a:t>28.10.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6F46D-F7B4-8244-8FAC-75F4A6F55D9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9912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A757C-A685-414B-9047-28E9F3FC19BD}" type="datetimeFigureOut">
              <a:rPr lang="fr-FR" smtClean="0"/>
              <a:t>28.10.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6F46D-F7B4-8244-8FAC-75F4A6F55D9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23901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A757C-A685-414B-9047-28E9F3FC19BD}" type="datetimeFigureOut">
              <a:rPr lang="fr-FR" smtClean="0"/>
              <a:t>28.10.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6F46D-F7B4-8244-8FAC-75F4A6F55D9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872609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A757C-A685-414B-9047-28E9F3FC19BD}" type="datetimeFigureOut">
              <a:rPr lang="fr-FR" smtClean="0"/>
              <a:t>28.10.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6F46D-F7B4-8244-8FAC-75F4A6F55D9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61214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A757C-A685-414B-9047-28E9F3FC19BD}" type="datetimeFigureOut">
              <a:rPr lang="fr-FR" smtClean="0"/>
              <a:t>28.10.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6F46D-F7B4-8244-8FAC-75F4A6F55D9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93672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A757C-A685-414B-9047-28E9F3FC19BD}" type="datetimeFigureOut">
              <a:rPr lang="fr-FR" smtClean="0"/>
              <a:t>28.10.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6F46D-F7B4-8244-8FAC-75F4A6F55D9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9881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A757C-A685-414B-9047-28E9F3FC19BD}" type="datetimeFigureOut">
              <a:rPr lang="fr-FR" smtClean="0"/>
              <a:t>28.10.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6F46D-F7B4-8244-8FAC-75F4A6F55D9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7469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A757C-A685-414B-9047-28E9F3FC19BD}" type="datetimeFigureOut">
              <a:rPr lang="fr-FR" smtClean="0"/>
              <a:t>28.10.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6F46D-F7B4-8244-8FAC-75F4A6F55D9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09573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A757C-A685-414B-9047-28E9F3FC19BD}" type="datetimeFigureOut">
              <a:rPr lang="fr-FR" smtClean="0"/>
              <a:t>28.10.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6F46D-F7B4-8244-8FAC-75F4A6F55D9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76110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A757C-A685-414B-9047-28E9F3FC19BD}" type="datetimeFigureOut">
              <a:rPr lang="fr-FR" smtClean="0"/>
              <a:t>28.10.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6F46D-F7B4-8244-8FAC-75F4A6F55D9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6052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H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A757C-A685-414B-9047-28E9F3FC19BD}" type="datetimeFigureOut">
              <a:rPr lang="fr-FR" smtClean="0"/>
              <a:t>28.10.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6F46D-F7B4-8244-8FAC-75F4A6F55D9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39600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H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H" smtClean="0"/>
              <a:t>Cliquez pour modifier les styles du texte du masque</a:t>
            </a:r>
          </a:p>
          <a:p>
            <a:pPr lvl="1"/>
            <a:r>
              <a:rPr lang="fr-CH" smtClean="0"/>
              <a:t>Deuxième niveau</a:t>
            </a:r>
          </a:p>
          <a:p>
            <a:pPr lvl="2"/>
            <a:r>
              <a:rPr lang="fr-CH" smtClean="0"/>
              <a:t>Troisième niveau</a:t>
            </a:r>
          </a:p>
          <a:p>
            <a:pPr lvl="3"/>
            <a:r>
              <a:rPr lang="fr-CH" smtClean="0"/>
              <a:t>Quatrième niveau</a:t>
            </a:r>
          </a:p>
          <a:p>
            <a:pPr lvl="4"/>
            <a:r>
              <a:rPr lang="fr-CH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AA757C-A685-414B-9047-28E9F3FC19BD}" type="datetimeFigureOut">
              <a:rPr lang="fr-FR" smtClean="0"/>
              <a:t>28.10.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66F46D-F7B4-8244-8FAC-75F4A6F55D9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8625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8"/>
          <p:cNvSpPr txBox="1"/>
          <p:nvPr/>
        </p:nvSpPr>
        <p:spPr>
          <a:xfrm>
            <a:off x="153173" y="164642"/>
            <a:ext cx="8531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Figure S3</a:t>
            </a:r>
            <a:endParaRPr lang="fr-FR" sz="1400" dirty="0"/>
          </a:p>
        </p:txBody>
      </p:sp>
      <p:sp>
        <p:nvSpPr>
          <p:cNvPr id="8" name="ZoneTexte 7"/>
          <p:cNvSpPr txBox="1"/>
          <p:nvPr/>
        </p:nvSpPr>
        <p:spPr>
          <a:xfrm>
            <a:off x="342900" y="540452"/>
            <a:ext cx="3765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A.</a:t>
            </a:r>
            <a:endParaRPr lang="fr-FR" dirty="0"/>
          </a:p>
        </p:txBody>
      </p:sp>
      <p:sp>
        <p:nvSpPr>
          <p:cNvPr id="10" name="ZoneTexte 9"/>
          <p:cNvSpPr txBox="1"/>
          <p:nvPr/>
        </p:nvSpPr>
        <p:spPr>
          <a:xfrm>
            <a:off x="342900" y="2158636"/>
            <a:ext cx="596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B</a:t>
            </a:r>
            <a:r>
              <a:rPr lang="fr-FR" dirty="0" smtClean="0"/>
              <a:t>.</a:t>
            </a:r>
            <a:endParaRPr lang="fr-FR" dirty="0"/>
          </a:p>
        </p:txBody>
      </p:sp>
      <p:graphicFrame>
        <p:nvGraphicFramePr>
          <p:cNvPr id="3" name="Tableau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6740868"/>
              </p:ext>
            </p:extLst>
          </p:nvPr>
        </p:nvGraphicFramePr>
        <p:xfrm>
          <a:off x="342900" y="2612730"/>
          <a:ext cx="6308627" cy="1285987"/>
        </p:xfrm>
        <a:graphic>
          <a:graphicData uri="http://schemas.openxmlformats.org/drawingml/2006/table">
            <a:tbl>
              <a:tblPr/>
              <a:tblGrid>
                <a:gridCol w="833805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940703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2244859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068980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220280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</a:tblGrid>
              <a:tr h="2202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cession</a:t>
                      </a:r>
                    </a:p>
                  </a:txBody>
                  <a:tcPr marL="10533" marR="10533" marT="105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rotein</a:t>
                      </a:r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fr-FR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ame</a:t>
                      </a:r>
                      <a:endParaRPr lang="fr-FR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0533" marR="10533" marT="105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e name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quence</a:t>
                      </a:r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fr-FR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ength</a:t>
                      </a:r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(</a:t>
                      </a:r>
                      <a:r>
                        <a:rPr lang="fr-FR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.a</a:t>
                      </a:r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.)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22023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07900</a:t>
                      </a:r>
                    </a:p>
                  </a:txBody>
                  <a:tcPr marL="10533" marR="10533" marT="105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90A_HUMAN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at shock protein HSP 90-alpha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P90AA1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32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86499">
                <a:tc>
                  <a:txBody>
                    <a:bodyPr/>
                    <a:lstStyle/>
                    <a:p>
                      <a:pPr algn="ctr" fontAlgn="ctr"/>
                      <a:r>
                        <a:rPr lang="cs-CZ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Q15149</a:t>
                      </a:r>
                    </a:p>
                  </a:txBody>
                  <a:tcPr marL="10533" marR="10533" marT="105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LEC_HUMAN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lectin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LEC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,684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77618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04083</a:t>
                      </a:r>
                    </a:p>
                  </a:txBody>
                  <a:tcPr marL="10533" marR="10533" marT="105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NXA1_HUMAN)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nnexin A1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NXA1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ru-RU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6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48666">
                <a:tc>
                  <a:txBody>
                    <a:bodyPr/>
                    <a:lstStyle/>
                    <a:p>
                      <a:pPr algn="ctr" fontAlgn="ctr"/>
                      <a:r>
                        <a:rPr lang="fi-FI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11021</a:t>
                      </a:r>
                    </a:p>
                  </a:txBody>
                  <a:tcPr marL="10533" marR="10533" marT="105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P_HUMAN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ndoplasmic reticulum chaperone BiP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PA5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54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30903">
                <a:tc>
                  <a:txBody>
                    <a:bodyPr/>
                    <a:lstStyle/>
                    <a:p>
                      <a:pPr algn="ctr" fontAlgn="ctr"/>
                      <a:r>
                        <a:rPr lang="cs-CZ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75369</a:t>
                      </a:r>
                    </a:p>
                  </a:txBody>
                  <a:tcPr marL="10533" marR="10533" marT="105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LNB_HUMAN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ilamin-B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LNB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,602</a:t>
                      </a:r>
                    </a:p>
                  </a:txBody>
                  <a:tcPr marL="10533" marR="10533" marT="10533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</a:tbl>
          </a:graphicData>
        </a:graphic>
      </p:graphicFrame>
      <p:graphicFrame>
        <p:nvGraphicFramePr>
          <p:cNvPr id="9" name="Tableau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06556744"/>
              </p:ext>
            </p:extLst>
          </p:nvPr>
        </p:nvGraphicFramePr>
        <p:xfrm>
          <a:off x="342900" y="959137"/>
          <a:ext cx="6264225" cy="1167357"/>
        </p:xfrm>
        <a:graphic>
          <a:graphicData uri="http://schemas.openxmlformats.org/drawingml/2006/table">
            <a:tbl>
              <a:tblPr/>
              <a:tblGrid>
                <a:gridCol w="586707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794311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2563458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209519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110230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</a:tblGrid>
              <a:tr h="231641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cession</a:t>
                      </a:r>
                    </a:p>
                  </a:txBody>
                  <a:tcPr marL="8894" marR="8894" marT="889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rotein</a:t>
                      </a:r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fr-FR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ame</a:t>
                      </a:r>
                      <a:endParaRPr lang="fr-FR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894" marR="8894" marT="889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e Name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quence length (a.a.)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94642">
                <a:tc>
                  <a:txBody>
                    <a:bodyPr/>
                    <a:lstStyle/>
                    <a:p>
                      <a:pPr algn="ctr" fontAlgn="ctr"/>
                      <a:r>
                        <a:rPr lang="es-ES_tradnl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Q86YZ3</a:t>
                      </a:r>
                    </a:p>
                  </a:txBody>
                  <a:tcPr marL="8894" marR="8894" marT="889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ORN_HUMAN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ornerin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894" marR="8894" marT="889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RNR 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50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77618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15924</a:t>
                      </a:r>
                    </a:p>
                  </a:txBody>
                  <a:tcPr marL="8894" marR="8894" marT="889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ESP_HUMAN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esmoplakin</a:t>
                      </a:r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(DP)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SP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71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13142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04264</a:t>
                      </a:r>
                    </a:p>
                  </a:txBody>
                  <a:tcPr marL="8894" marR="8894" marT="889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2C1_HUMAN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eratin</a:t>
                      </a:r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, type II </a:t>
                      </a:r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ytoskeletal</a:t>
                      </a:r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1 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RT1 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44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04260">
                <a:tc>
                  <a:txBody>
                    <a:bodyPr/>
                    <a:lstStyle/>
                    <a:p>
                      <a:pPr algn="ctr" fontAlgn="ctr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35527</a:t>
                      </a:r>
                    </a:p>
                  </a:txBody>
                  <a:tcPr marL="8894" marR="8894" marT="889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1C9_HUMAN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eratin</a:t>
                      </a:r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, type I </a:t>
                      </a:r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ytoskeletal</a:t>
                      </a:r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9 (Cytokeratin-9)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RT9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23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142299">
                <a:tc>
                  <a:txBody>
                    <a:bodyPr/>
                    <a:lstStyle/>
                    <a:p>
                      <a:pPr algn="ctr" fontAlgn="ctr"/>
                      <a:r>
                        <a:rPr lang="fi-FI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02533</a:t>
                      </a:r>
                    </a:p>
                  </a:txBody>
                  <a:tcPr marL="8894" marR="8894" marT="889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1C14_HUMAN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eratin</a:t>
                      </a:r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, type I </a:t>
                      </a:r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ytoskeletal</a:t>
                      </a:r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14 (Cytokeratin-14) 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RT14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72</a:t>
                      </a:r>
                    </a:p>
                  </a:txBody>
                  <a:tcPr marL="8894" marR="8894" marT="8894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3036737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19</Words>
  <Application>Microsoft Macintosh PowerPoint</Application>
  <PresentationFormat>Présentation à l'écran (4:3)</PresentationFormat>
  <Paragraphs>6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UNIG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sabelle Ruchonnet</dc:creator>
  <cp:lastModifiedBy>Isabelle Ruchonnet</cp:lastModifiedBy>
  <cp:revision>2</cp:revision>
  <dcterms:created xsi:type="dcterms:W3CDTF">2019-10-28T21:26:34Z</dcterms:created>
  <dcterms:modified xsi:type="dcterms:W3CDTF">2019-10-28T21:30:42Z</dcterms:modified>
</cp:coreProperties>
</file>